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87" d="100"/>
          <a:sy n="87" d="100"/>
        </p:scale>
        <p:origin x="34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742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201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114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612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031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550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661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594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245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305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017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848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D23350A-FCB7-549F-46E5-153787FE736A}"/>
              </a:ext>
            </a:extLst>
          </p:cNvPr>
          <p:cNvSpPr txBox="1"/>
          <p:nvPr/>
        </p:nvSpPr>
        <p:spPr>
          <a:xfrm>
            <a:off x="974445" y="2558450"/>
            <a:ext cx="5013399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ata availability</a:t>
            </a:r>
            <a:endParaRPr lang="en-US" altLang="en-US" sz="1200" dirty="0"/>
          </a:p>
          <a:p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he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cRN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-seq data have been deposited in the GEO database under accession code GSE275858. Additional information and/or reagents are available from the authors on request. </a:t>
            </a:r>
            <a:endParaRPr lang="en-US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65B9D8D-1EEE-8643-7D32-DB23C6E72D6D}"/>
              </a:ext>
            </a:extLst>
          </p:cNvPr>
          <p:cNvSpPr txBox="1"/>
          <p:nvPr/>
        </p:nvSpPr>
        <p:spPr>
          <a:xfrm>
            <a:off x="530942" y="825908"/>
            <a:ext cx="50919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4D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UMAP presentation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cRNASeq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data derived with Loupe program</a:t>
            </a:r>
          </a:p>
        </p:txBody>
      </p:sp>
    </p:spTree>
    <p:extLst>
      <p:ext uri="{BB962C8B-B14F-4D97-AF65-F5344CB8AC3E}">
        <p14:creationId xmlns:p14="http://schemas.microsoft.com/office/powerpoint/2010/main" val="1548561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42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ncy Reich Marshall</dc:creator>
  <cp:lastModifiedBy>Nancy Reich Marshall</cp:lastModifiedBy>
  <cp:revision>1</cp:revision>
  <dcterms:created xsi:type="dcterms:W3CDTF">2025-06-10T18:50:08Z</dcterms:created>
  <dcterms:modified xsi:type="dcterms:W3CDTF">2025-06-10T18:52:04Z</dcterms:modified>
</cp:coreProperties>
</file>